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  <p:sldId id="287" r:id="rId3"/>
    <p:sldId id="290" r:id="rId4"/>
    <p:sldId id="285" r:id="rId5"/>
    <p:sldId id="267" r:id="rId6"/>
    <p:sldId id="269" r:id="rId7"/>
    <p:sldId id="273" r:id="rId8"/>
    <p:sldId id="268" r:id="rId9"/>
    <p:sldId id="264" r:id="rId10"/>
    <p:sldId id="276" r:id="rId11"/>
    <p:sldId id="275" r:id="rId12"/>
    <p:sldId id="266" r:id="rId13"/>
    <p:sldId id="280" r:id="rId14"/>
    <p:sldId id="279" r:id="rId15"/>
    <p:sldId id="283" r:id="rId16"/>
    <p:sldId id="278" r:id="rId17"/>
    <p:sldId id="293" r:id="rId18"/>
    <p:sldId id="303" r:id="rId19"/>
    <p:sldId id="298" r:id="rId20"/>
    <p:sldId id="292" r:id="rId21"/>
  </p:sldIdLst>
  <p:sldSz cx="12192000" cy="6858000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42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62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5391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1664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0052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3878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5636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5136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6077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9956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9650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637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1130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5D3B7-BEA5-4604-96B0-98489559C30C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F88C8-B25A-4D1A-8C2B-C764B5B65F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9036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818515">
            <a:off x="3286126" y="180975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7BBF901-7237-7E4D-5DF1-6F9AC5294AC2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3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17692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192411">
            <a:off x="3244850" y="-4445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C84E182-E564-06D4-477C-3D4442319FB9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13599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192411">
            <a:off x="3244850" y="-4445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DB313EF-C8B7-7657-627C-9EBE55D3422F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326331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868611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595186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2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63771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9199" y="1814512"/>
            <a:ext cx="2714625" cy="1628775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2486" y="1814512"/>
            <a:ext cx="2714625" cy="1628775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35390" y="1814512"/>
            <a:ext cx="2714625" cy="1628775"/>
          </a:xfrm>
          <a:prstGeom prst="rect">
            <a:avLst/>
          </a:prstGeom>
        </p:spPr>
      </p:pic>
      <p:cxnSp>
        <p:nvCxnSpPr>
          <p:cNvPr id="17" name="직선 연결선 16"/>
          <p:cNvCxnSpPr/>
          <p:nvPr/>
        </p:nvCxnSpPr>
        <p:spPr>
          <a:xfrm>
            <a:off x="1894113" y="1955979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5740963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443376">
            <a:off x="2901951" y="-336549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02F5647-8C84-E391-58A4-4DA42A9BC308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6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125639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443376">
            <a:off x="2901951" y="-336549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7DA6956-8D2E-5525-B974-091668B141A1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6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285102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900171">
            <a:off x="3930650" y="-742951"/>
            <a:ext cx="5905500" cy="5905500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9900171">
            <a:off x="3930650" y="-742951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8DE0C3-3ADF-C6CD-0FE3-F151ED47FC2C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6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052940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6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868611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595186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2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63771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582" y="1814511"/>
            <a:ext cx="2714625" cy="1628775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2300" y="1816097"/>
            <a:ext cx="2714625" cy="1628775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35390" y="1814511"/>
            <a:ext cx="2714625" cy="1628775"/>
          </a:xfrm>
          <a:prstGeom prst="rect">
            <a:avLst/>
          </a:prstGeom>
        </p:spPr>
      </p:pic>
      <p:cxnSp>
        <p:nvCxnSpPr>
          <p:cNvPr id="19" name="직선 연결선 18"/>
          <p:cNvCxnSpPr/>
          <p:nvPr/>
        </p:nvCxnSpPr>
        <p:spPr>
          <a:xfrm>
            <a:off x="1894113" y="1930219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745752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904013">
            <a:off x="3137377" y="228312"/>
            <a:ext cx="5295900" cy="5295900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9904013">
            <a:off x="3137377" y="228312"/>
            <a:ext cx="5295900" cy="5295900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9904013">
            <a:off x="3137377" y="228312"/>
            <a:ext cx="5295900" cy="5295900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9900988">
            <a:off x="3138324" y="229259"/>
            <a:ext cx="5295900" cy="52959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50C164E-CFF4-1EF5-0E29-46C9FA5F067D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544556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5A084BE9-7B0A-5D26-BD29-C0CBE719AE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895507">
            <a:off x="3130859" y="226503"/>
            <a:ext cx="5295600" cy="52956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4B993F4-94EF-F923-A3C4-750A4C83D11A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114980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180380">
            <a:off x="3333751" y="-924379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9F7F5E3-91F8-A369-682F-8C95349A66F9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25933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818515">
            <a:off x="3286126" y="180975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40AB1C2-43CD-B206-5236-6922B39D07BE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3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993326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209" y="1814511"/>
            <a:ext cx="2710090" cy="1627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868611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595186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2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63771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1894113" y="1943099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그림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5389" y="1814511"/>
            <a:ext cx="2714625" cy="1628775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E9BAB963-7228-B6C5-397C-0E611D92AF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56612" y="1820882"/>
            <a:ext cx="2714400" cy="16208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27668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7268883">
            <a:off x="2841172" y="117022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1A1AFC0-8778-A6D8-349E-5A85FD2FDAFA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3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71949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7043" y="1816086"/>
            <a:ext cx="2716779" cy="1627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3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868611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595186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2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63771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직선 연결선 15"/>
          <p:cNvCxnSpPr/>
          <p:nvPr/>
        </p:nvCxnSpPr>
        <p:spPr>
          <a:xfrm>
            <a:off x="1894113" y="1955979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그림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3062" y="1816086"/>
            <a:ext cx="2714047" cy="1627200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26349" y="1816086"/>
            <a:ext cx="2714047" cy="162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10887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7104518">
            <a:off x="3333750" y="27305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0B0F54F-51D9-EB45-C941-FA2696031C37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28377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7104518">
            <a:off x="3333750" y="27305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7B093C3-E579-F09F-2595-B9958C9A2416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13700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232159">
            <a:off x="2795267" y="196848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B4B98AF-8526-8951-3669-CA8ABA0612AE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3738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868611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595186" y="12451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2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63771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9198" y="1814512"/>
            <a:ext cx="2714625" cy="1628775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2485" y="1814512"/>
            <a:ext cx="2714625" cy="1628775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25772" y="1800225"/>
            <a:ext cx="2714625" cy="1628775"/>
          </a:xfrm>
          <a:prstGeom prst="rect">
            <a:avLst/>
          </a:prstGeom>
        </p:spPr>
      </p:pic>
      <p:cxnSp>
        <p:nvCxnSpPr>
          <p:cNvPr id="16" name="직선 연결선 15"/>
          <p:cNvCxnSpPr/>
          <p:nvPr/>
        </p:nvCxnSpPr>
        <p:spPr>
          <a:xfrm>
            <a:off x="1894113" y="1955978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56494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71150">
            <a:off x="3633106" y="-42999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DA961B2-7C3C-5236-C738-4AA16AAC8E22}"/>
              </a:ext>
            </a:extLst>
          </p:cNvPr>
          <p:cNvSpPr txBox="1"/>
          <p:nvPr/>
        </p:nvSpPr>
        <p:spPr>
          <a:xfrm>
            <a:off x="0" y="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8131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</TotalTime>
  <Words>35</Words>
  <Application>Microsoft Office PowerPoint</Application>
  <PresentationFormat>와이드스크린</PresentationFormat>
  <Paragraphs>35</Paragraphs>
  <Slides>2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0</vt:i4>
      </vt:variant>
    </vt:vector>
  </HeadingPairs>
  <TitlesOfParts>
    <vt:vector size="23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bri</dc:creator>
  <cp:lastModifiedBy>이 원영</cp:lastModifiedBy>
  <cp:revision>21</cp:revision>
  <cp:lastPrinted>2019-01-28T09:18:14Z</cp:lastPrinted>
  <dcterms:created xsi:type="dcterms:W3CDTF">2019-01-28T02:56:18Z</dcterms:created>
  <dcterms:modified xsi:type="dcterms:W3CDTF">2024-09-30T04:55:11Z</dcterms:modified>
</cp:coreProperties>
</file>